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516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285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238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473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549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20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680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67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505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428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767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351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C5B73-CBE8-4BDA-A7E0-71AE96E36A84}" type="datetimeFigureOut">
              <a:rPr lang="en-US" smtClean="0"/>
              <a:t>12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9FB8C-8C83-46A2-BA9A-17182BE50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16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2" name="Picture 2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171" y="0"/>
            <a:ext cx="2460333" cy="271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3" name="Picture 2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374" y="2514600"/>
            <a:ext cx="2528887" cy="2566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4" name="Picture 30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0608" y="0"/>
            <a:ext cx="2231819" cy="271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5" name="Picture 3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7934" y="2530876"/>
            <a:ext cx="2300373" cy="24221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6" name="Picture 3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9408" y="0"/>
            <a:ext cx="2231819" cy="271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7" name="Picture 3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5980" y="2538623"/>
            <a:ext cx="2300373" cy="27191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8" name="Picture 3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8035" y="0"/>
            <a:ext cx="2231819" cy="25668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59" name="Picture 3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4027" y="2535936"/>
            <a:ext cx="2300373" cy="22774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" name="TextBox 39"/>
          <p:cNvSpPr txBox="1"/>
          <p:nvPr/>
        </p:nvSpPr>
        <p:spPr>
          <a:xfrm>
            <a:off x="1020222" y="11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925222" y="11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754022" y="11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C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582822" y="116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D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020222" y="2438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E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925222" y="24384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754022" y="243840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G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582822" y="24384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H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0" y="5105400"/>
            <a:ext cx="9144000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Altered IL-6 and IP-10 levels in SLE patients and lupus relatives 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respective of medication.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Plasma levels of IL-6 (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-D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 and IP-10 (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H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 were assessed in SLE patients (case), unaffected first-degree relatives of SLE patients (FDR), and unrelated, unaffected controls with no family history of SLE (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. Soluble mediator levels were compared in each group by use of prednisone (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, E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, hydroxychloroquine (HCQ;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, F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suppressant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(IS;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, G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, including methotrexate and/or azathioprine, and/or major 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unosuppressants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(Major IS;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, H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), including mycophenolate 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ofetil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and/or cyclophosphamide. Y = Yes; N = No. Data are presented as mean </a:t>
            </a:r>
            <a:r>
              <a:rPr lang="en-US" sz="13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SEM. *</a:t>
            </a:r>
            <a:r>
              <a:rPr lang="en-US" sz="13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, **</a:t>
            </a:r>
            <a:r>
              <a:rPr lang="en-US" sz="13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&lt;0.01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, ***</a:t>
            </a:r>
            <a:r>
              <a:rPr lang="en-US" sz="13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1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, ****</a:t>
            </a:r>
            <a:r>
              <a:rPr lang="en-US" sz="13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US" sz="13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-Wallis test with Dunn’s multiple 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en-US" sz="13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or all groups assessed (Case/FDR/</a:t>
            </a:r>
            <a:r>
              <a:rPr lang="en-US" sz="13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l</a:t>
            </a:r>
            <a:r>
              <a:rPr lang="en-US" sz="13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th (Y) or without (N) use of the medications indicated)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3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y comparisons found to be statistically significant </a:t>
            </a:r>
            <a:r>
              <a:rPr lang="en-US" sz="13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30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d.</a:t>
            </a:r>
            <a:endParaRPr lang="en-US" sz="13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2851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189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ssa Munroe, MD, PhD</dc:creator>
  <cp:lastModifiedBy>Melissa Munroe, MD, PhD</cp:lastModifiedBy>
  <cp:revision>12</cp:revision>
  <dcterms:created xsi:type="dcterms:W3CDTF">2016-09-26T17:53:58Z</dcterms:created>
  <dcterms:modified xsi:type="dcterms:W3CDTF">2016-12-09T22:25:27Z</dcterms:modified>
</cp:coreProperties>
</file>